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80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5334000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ure S4.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Relative expression of genes related to transcriptional factors. Data is presented as the mean ± standard deviation (n = 9). </a:t>
            </a:r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 descr="E:\科研\黄瓜皮色测序\自己投稿\整理图表\Supplemental materials\Figure S4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0799" y="346844"/>
            <a:ext cx="3794125" cy="49578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93249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PC</cp:lastModifiedBy>
  <cp:revision>1</cp:revision>
  <dcterms:created xsi:type="dcterms:W3CDTF">2006-08-16T00:00:00Z</dcterms:created>
  <dcterms:modified xsi:type="dcterms:W3CDTF">2020-04-16T07:37:12Z</dcterms:modified>
</cp:coreProperties>
</file>